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464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18D4B-A477-49AE-BAF4-6E933DC6AADB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DBA67-F4E5-4776-87DF-72BFD43A291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5"/>
          <p:cNvGrpSpPr>
            <a:grpSpLocks/>
          </p:cNvGrpSpPr>
          <p:nvPr/>
        </p:nvGrpSpPr>
        <p:grpSpPr bwMode="auto">
          <a:xfrm>
            <a:off x="457200" y="-76200"/>
            <a:ext cx="5943600" cy="10172700"/>
            <a:chOff x="457200" y="-76165"/>
            <a:chExt cx="5943600" cy="10172701"/>
          </a:xfrm>
        </p:grpSpPr>
        <p:sp>
          <p:nvSpPr>
            <p:cNvPr id="7172" name="Rectangle 4"/>
            <p:cNvSpPr>
              <a:spLocks noChangeArrowheads="1"/>
            </p:cNvSpPr>
            <p:nvPr/>
          </p:nvSpPr>
          <p:spPr bwMode="auto">
            <a:xfrm>
              <a:off x="457200" y="-76165"/>
              <a:ext cx="5943600" cy="101727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	        1     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</a:rPr>
                <a:t>                           </a:t>
              </a:r>
              <a:r>
                <a:rPr lang="en-US" altLang="zh-TW" sz="800">
                  <a:latin typeface="Courier New" pitchFamily="49" charset="0"/>
                  <a:ea typeface="新細明體" pitchFamily="18" charset="-120"/>
                </a:rPr>
                <a:t> </a:t>
              </a:r>
              <a:r>
                <a:rPr lang="en-US" altLang="zh-TW" sz="1200">
                  <a:latin typeface="Courier New" pitchFamily="49" charset="0"/>
                  <a:ea typeface="新細明體" pitchFamily="18" charset="-120"/>
                </a:rPr>
                <a:t>   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6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  (1) MFLELRVVFKMWIIALSLCLENIILIHAVHIECELPSILKKEKEQCFNILSAEAHN--R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  (1) -MTTSDWLWSTGIWALALLLR----PAAAQLSCDLLRVLKMQEDLCTEALAAENVS--RN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  (1) MLSTMSPRLSLLLLWLLLLINAAHPVGALPRLCDVRRVLLEERAECLRELSEEKK-ALGP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  (1) MLSTMRPRLSLLLLRLLLLTKAAHTVGVPPRLCDVRRVLLEERAHCLQQLSKEKKGALGP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  (1) ----MRPRLPPLPG-LLLLACAVHAVGTPPRLCDVLRVLRVERDQCLQELSRE-----S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  (1) MRPHLSPPLQQLLL-PVLLACAAHSTGALPRLCDVLQVLWEEQDQCLQELSREQTGDLGT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  (1) --MCPRPGPPLGLWLLLGFACAAHLVGAPPRLCDVLWVLQEERDQCLQELERER---LGE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  (1) M   MRP L LLLL LLLL  AAH VGA PRLCDVLRVL EERDQCLQELSRE    LG 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61                                                       12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 (59) ENQEL------------QA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AGEWDNVTCWPSAAVRQTVSVPCPEFISLLTGVKDFIY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 (54) YWP--------------EG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VGKWDKISCWPSSALGETVTIPCPEILQGFTDQQGSLY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 (60) KTASAIVFSPSAPSYTVHQ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ERFWDNMSCWPSSALAQTVEVPCPKFLRMFSGRNGSL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 (61) ETAS---------------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EGLWDNMSCWPSSAPARTVEVQCPKFLLMLSNKNGSL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 (51) EHPA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P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--------------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RGLWDNTSCWPSSALGQTVEVACPRFLWMLVGRNGSM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 (60) EQPV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P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--------------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EGMWDNISCWPSSVPGRMVEVECPRFLRMLTSRNGSL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 (56) EQPV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P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--------------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GCQGLWDNVSCWPSSAPGRMVELECPRFLRMLTNSNGSL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 (61) E P                GC GLWDNISCWPSSALG TVEV CPRFL MLT RNGSLFR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121                                                      18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107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INGWSEAFPRLETACGYKVN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DTTTDDKTSYYSNLKTMYTVGYSTSFLSLSVAVIIL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100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KDGWSTRFPSIDVACGYD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ANIT---DNVVYFMHLKTLYTAGYGTSLASLALALALLA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120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KDGWSETFPRPDLACGVN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MNGSFNERRHAYLLKLKVMYTVGYSSSLAMLLVALS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106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QDGWSETFPRPDLACGVNIN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NSFNERRHAYLLKLKVMYTVGYSSSLAMLLVALS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 (97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QGGWSETFPRPDLACGVNVN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DSSNEKRYEYLLKLKIMYTVGYSSSLVMLLVALS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106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QDGWSETFPRPNLACGVNVN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DSSNEKRHSYLLKLKVMYTVGYSSSLVMLLVALG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102) </a:t>
              </a:r>
              <a:r>
                <a:rPr lang="en-US" altLang="zh-TW" sz="900" b="1">
                  <a:latin typeface="Courier New" pitchFamily="49" charset="0"/>
                  <a:ea typeface="新細明體" pitchFamily="18" charset="-120"/>
                </a:rPr>
                <a:t>NCTQDGWTETFPRPDLACGVS</a:t>
              </a:r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MNDSSHERQHAYLLKLKVMYTVGYSSSLVMLLVALG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121) NCTQDGWSETFPRPDLACGVNVNDSSNERRHAYLLKLKVMYTVGYSSSLVMLLVALSILC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181                                                      24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167) FFRKLRCTRNYIHMHLFTSFILRALSVLIKDSVLFSSKDIDHCSAYASSGCKFVVVFY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157) SFRRLRCTRNYIHMHLFVSFILRAMSIFIKDAVLYSTEDINHCNIYSTD-CSFLMI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180) SFRRLHCTRNYIHMHLFVSFILRALSNFIKDAVLFPADDVTYCDAHRAG-CKLVMI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166) SFRRLHCTRNYIHMHLFVSFILRALSNFIKDAVLFSSDDVTYCDAHKVG-CKLVMI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(157) AFRRLHCTRNYIHMHLFVSFILRALSNFIKDAVLFSSDDATHCDAHRVG-CKLVMV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166) AFRRLHCTRNYIHMHLFVSFILRALSNFIKDAVLFSSDDVTYCDAHRAG-CKLVMVL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162) AFRRLHCTRNYIHMHLFLSFILRALSNFIKDAVLFSSDDAIHCDAHRVG-CKLVMV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181) AFRRLHCTRNYIHMHLFVSFILRALSNFIKDAVLFSSDDVTHCDAHR G CKLVMVFFQ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241                                                      30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227) CIMANYSWLLVEGLYLHSLLVISFFSERKYFWWYITLGWGLPSVFIIAWSIARQLLEDI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216) CIMANYSWLLVEGLYLHTLLVISFFSEWKYFCWYIALGWGSPLVFIIAWAVCRHLYENI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239) CIMANYAWLLVEGLYLHTLLAISFFSERKCLQAFVLFGWGSPAIFVALWAVTRHFLEDF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225) CIMANYAWLLVEGLYLHTLLAISFFSERKYLQAFVLLGWGSPAIFVALWAITRHFLENT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(216) CIMANYSWLLVEGLYLHTLLVISFFSERKWLQGFVALGWGSPAIFVASWAVTRHFLEDV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225) CIMANYSWLLVEGLYLHTLLAISFFSERKYLQGFVAFGWGSPAIFVALWAIARHFLEDV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221) CIMANYAWLLVEGLYLHSLLVVSFFSERKCLQGFVVLGWGSPAMFVTSWAVTRHFLEDS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241) CIMANYSWLLVEGLYLHTLLVISFFSERKYLQGFV LGWGSPAIFVAAWAVTRHFLEDIG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301                                                      36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287) CWDININAEIWWIIKGPIILSIFINFILFVSIIRILIKKLKTPDVRG-SNFNQYKRLAK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276) CWDINSNASIWWIIRGPVILSIFINFILFVRIIRILMKKLKATDVVSRNDFGQYKRLAR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299) CWDINSNASIWWVIRGPVILSIVINFIFFINILRILMRKLRTQETRG-NETHHYKRLAK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285) CWDINANASVWWVIRGPVILSILINFIFFINILRILMRKLRTQETRG-SETNHYKRLAK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(276) CWDINANASIWWVIRGPVILSILINFILFINILRILMRRLRTQETRG-NEVNHYKRLAK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285) CWDINANASIWWIIRGPVILSILFNFILFINILRILMRKLRTQETRG-NQVSHYKRLAR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281) CWDINANAAIWWVIRGPVILSILINFILFINILRILTRKLRTQETRG-QDMNHYKRLAR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301) CWDINANASIWWVIRGPVILSILINFILFINILRILMRKLRTQETRG NE NHYKRLAKS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361                                                      420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346) TLLLIPLFGVHYITFTIFPEEVSAVTAEIRLYVELAVGSFQGFVVAVLYCFLNGEVQSEI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336) TLLLIPLFGVHYMVFAFFPEDVSSGTVEIRLSFELTLGSFQGFVVAVLYCFLNGEVQSEI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358) TLLLIPLFGIHYIVFAFSPEG----AMEV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344) TLLLIPLFGIHYIVFAFSPED----AMEV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(335) TLLLIPLFGIHYIIFAFSPED----AMEI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344) TLLLIPLFGIHYIVFAFSPED----AMEI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340) TLLLIPLFGVHYIVFVFSPEG----AMEI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361) TLLLIPLFGIHYIVFAFSPED    AMEIQLFFELALGSFQGLVVAVLYCFLNGEVQLEV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                 421                                                    478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P. dolloi  (406) KRKWRRWKLKKHFDVDFRHPRNSTTSNGTNGMTLVSLLTRSSPKDQRKSFDHSLAEKY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X. laevis  (396) QRKWRRWHFREYFLLRQQK--NSIVSNGVTVLTQVLPVSRSSNKEQRNTPAQKTSVI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M. musculus  (414) QKKWRQWHLQEFPLRPVAL--SNSFSNATNGPTHSTKAGTSE--QSRSIPGANVI--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R. norvegicus  (400) QKKWRQWHLQEFPLRPVAF--NNSFSNATNGPTHSTKASTE---QSRSIPRASII--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B. taurus  (391) QKKWRQWHLRELPLRPVAP--SSSFSNGIKASTSEQSRATHR--TSVI---------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H. sapiens  (400) QKKWQQWHLREFPLHPVA-----SFSNSTKASHLEQSQGTCR--TSII---------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O. cuniculus  (396) QKKWQQWHLWEPPLCPVAL--SSSFSNGTSSLN-STKACPSG--RSRDTCKVSII---</a:t>
              </a:r>
            </a:p>
            <a:p>
              <a:r>
                <a:rPr lang="en-US" altLang="zh-TW" sz="900">
                  <a:latin typeface="Courier New" pitchFamily="49" charset="0"/>
                  <a:ea typeface="新細明體" pitchFamily="18" charset="-120"/>
                </a:rPr>
                <a:t>    Consensus  (421) QKKWRQWHLREFPL PVA    SSFSNGT G T  T   TS    SR      I    </a:t>
              </a:r>
            </a:p>
            <a:p>
              <a:pPr>
                <a:spcBef>
                  <a:spcPct val="50000"/>
                </a:spcBef>
              </a:pPr>
              <a:endParaRPr lang="en-US" altLang="zh-TW" sz="900">
                <a:latin typeface="Courier New" pitchFamily="49" charset="0"/>
                <a:ea typeface="新細明體" pitchFamily="18" charset="-120"/>
              </a:endParaRPr>
            </a:p>
          </p:txBody>
        </p:sp>
        <p:sp>
          <p:nvSpPr>
            <p:cNvPr id="7173" name="Line 5"/>
            <p:cNvSpPr>
              <a:spLocks noChangeShapeType="1"/>
            </p:cNvSpPr>
            <p:nvPr/>
          </p:nvSpPr>
          <p:spPr bwMode="auto">
            <a:xfrm>
              <a:off x="4724400" y="2608246"/>
              <a:ext cx="13716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74" name="Line 6"/>
            <p:cNvSpPr>
              <a:spLocks noChangeShapeType="1"/>
            </p:cNvSpPr>
            <p:nvPr/>
          </p:nvSpPr>
          <p:spPr bwMode="auto">
            <a:xfrm>
              <a:off x="1981200" y="3838610"/>
              <a:ext cx="2159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75" name="Text Box 7"/>
            <p:cNvSpPr txBox="1">
              <a:spLocks noChangeArrowheads="1"/>
            </p:cNvSpPr>
            <p:nvPr/>
          </p:nvSpPr>
          <p:spPr bwMode="auto">
            <a:xfrm>
              <a:off x="5181600" y="2422509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1</a:t>
              </a:r>
            </a:p>
          </p:txBody>
        </p:sp>
        <p:sp>
          <p:nvSpPr>
            <p:cNvPr id="7176" name="Line 8"/>
            <p:cNvSpPr>
              <a:spLocks noChangeShapeType="1"/>
            </p:cNvSpPr>
            <p:nvPr/>
          </p:nvSpPr>
          <p:spPr bwMode="auto">
            <a:xfrm>
              <a:off x="2994025" y="3856028"/>
              <a:ext cx="13716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77" name="Text Box 9"/>
            <p:cNvSpPr txBox="1">
              <a:spLocks noChangeArrowheads="1"/>
            </p:cNvSpPr>
            <p:nvPr/>
          </p:nvSpPr>
          <p:spPr bwMode="auto">
            <a:xfrm>
              <a:off x="3429000" y="3667116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2</a:t>
              </a:r>
            </a:p>
          </p:txBody>
        </p:sp>
        <p:sp>
          <p:nvSpPr>
            <p:cNvPr id="7178" name="Line 10"/>
            <p:cNvSpPr>
              <a:spLocks noChangeShapeType="1"/>
            </p:cNvSpPr>
            <p:nvPr/>
          </p:nvSpPr>
          <p:spPr bwMode="auto">
            <a:xfrm>
              <a:off x="5649913" y="3838610"/>
              <a:ext cx="44608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79" name="Line 11"/>
            <p:cNvSpPr>
              <a:spLocks noChangeShapeType="1"/>
            </p:cNvSpPr>
            <p:nvPr/>
          </p:nvSpPr>
          <p:spPr bwMode="auto">
            <a:xfrm>
              <a:off x="1992313" y="5095876"/>
              <a:ext cx="1143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80" name="Text Box 12"/>
            <p:cNvSpPr txBox="1">
              <a:spLocks noChangeArrowheads="1"/>
            </p:cNvSpPr>
            <p:nvPr/>
          </p:nvSpPr>
          <p:spPr bwMode="auto">
            <a:xfrm>
              <a:off x="2286000" y="4922839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3</a:t>
              </a:r>
            </a:p>
          </p:txBody>
        </p:sp>
        <p:sp>
          <p:nvSpPr>
            <p:cNvPr id="7181" name="Line 13"/>
            <p:cNvSpPr>
              <a:spLocks noChangeShapeType="1"/>
            </p:cNvSpPr>
            <p:nvPr/>
          </p:nvSpPr>
          <p:spPr bwMode="auto">
            <a:xfrm>
              <a:off x="3962400" y="5095876"/>
              <a:ext cx="16002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82" name="Text Box 14"/>
            <p:cNvSpPr txBox="1">
              <a:spLocks noChangeArrowheads="1"/>
            </p:cNvSpPr>
            <p:nvPr/>
          </p:nvSpPr>
          <p:spPr bwMode="auto">
            <a:xfrm>
              <a:off x="4572000" y="4922839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4</a:t>
              </a:r>
            </a:p>
          </p:txBody>
        </p:sp>
        <p:sp>
          <p:nvSpPr>
            <p:cNvPr id="7183" name="Text Box 15"/>
            <p:cNvSpPr txBox="1">
              <a:spLocks noChangeArrowheads="1"/>
            </p:cNvSpPr>
            <p:nvPr/>
          </p:nvSpPr>
          <p:spPr bwMode="auto">
            <a:xfrm>
              <a:off x="3124200" y="6167446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5</a:t>
              </a:r>
            </a:p>
          </p:txBody>
        </p:sp>
        <p:sp>
          <p:nvSpPr>
            <p:cNvPr id="7184" name="Line 16"/>
            <p:cNvSpPr>
              <a:spLocks noChangeShapeType="1"/>
            </p:cNvSpPr>
            <p:nvPr/>
          </p:nvSpPr>
          <p:spPr bwMode="auto">
            <a:xfrm>
              <a:off x="2593975" y="6340484"/>
              <a:ext cx="15113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85" name="Rectangle 17"/>
            <p:cNvSpPr>
              <a:spLocks noChangeArrowheads="1"/>
            </p:cNvSpPr>
            <p:nvPr/>
          </p:nvSpPr>
          <p:spPr bwMode="auto">
            <a:xfrm>
              <a:off x="4071942" y="6337317"/>
              <a:ext cx="346075" cy="11160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prstDash val="sysDot"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7186" name="Line 18"/>
            <p:cNvSpPr>
              <a:spLocks noChangeShapeType="1"/>
            </p:cNvSpPr>
            <p:nvPr/>
          </p:nvSpPr>
          <p:spPr bwMode="auto">
            <a:xfrm>
              <a:off x="1987200" y="7570800"/>
              <a:ext cx="12827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87" name="Text Box 19"/>
            <p:cNvSpPr txBox="1">
              <a:spLocks noChangeArrowheads="1"/>
            </p:cNvSpPr>
            <p:nvPr/>
          </p:nvSpPr>
          <p:spPr bwMode="auto">
            <a:xfrm>
              <a:off x="2362200" y="7381892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6</a:t>
              </a:r>
            </a:p>
          </p:txBody>
        </p:sp>
        <p:sp>
          <p:nvSpPr>
            <p:cNvPr id="7188" name="Line 20"/>
            <p:cNvSpPr>
              <a:spLocks noChangeShapeType="1"/>
            </p:cNvSpPr>
            <p:nvPr/>
          </p:nvSpPr>
          <p:spPr bwMode="auto">
            <a:xfrm>
              <a:off x="6000768" y="6310322"/>
              <a:ext cx="7143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89" name="Line 21"/>
            <p:cNvSpPr>
              <a:spLocks noChangeShapeType="1"/>
            </p:cNvSpPr>
            <p:nvPr/>
          </p:nvSpPr>
          <p:spPr bwMode="auto">
            <a:xfrm>
              <a:off x="4246563" y="7570800"/>
              <a:ext cx="15621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190" name="Text Box 22"/>
            <p:cNvSpPr txBox="1">
              <a:spLocks noChangeArrowheads="1"/>
            </p:cNvSpPr>
            <p:nvPr/>
          </p:nvSpPr>
          <p:spPr bwMode="auto">
            <a:xfrm>
              <a:off x="4800600" y="7381892"/>
              <a:ext cx="4572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zh-TW" sz="1000" b="1" i="1">
                  <a:ea typeface="新細明體" pitchFamily="18" charset="-120"/>
                </a:rPr>
                <a:t>TM7</a:t>
              </a:r>
            </a:p>
          </p:txBody>
        </p:sp>
        <p:sp>
          <p:nvSpPr>
            <p:cNvPr id="7191" name="Text Box 23"/>
            <p:cNvSpPr txBox="1">
              <a:spLocks noChangeArrowheads="1"/>
            </p:cNvSpPr>
            <p:nvPr/>
          </p:nvSpPr>
          <p:spPr bwMode="auto">
            <a:xfrm>
              <a:off x="4079875" y="22260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2" name="Text Box 24"/>
            <p:cNvSpPr txBox="1">
              <a:spLocks noChangeArrowheads="1"/>
            </p:cNvSpPr>
            <p:nvPr/>
          </p:nvSpPr>
          <p:spPr bwMode="auto">
            <a:xfrm>
              <a:off x="4953000" y="22260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3" name="Text Box 25"/>
            <p:cNvSpPr txBox="1">
              <a:spLocks noChangeArrowheads="1"/>
            </p:cNvSpPr>
            <p:nvPr/>
          </p:nvSpPr>
          <p:spPr bwMode="auto">
            <a:xfrm>
              <a:off x="3878263" y="1241460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4" name="Text Box 26"/>
            <p:cNvSpPr txBox="1">
              <a:spLocks noChangeArrowheads="1"/>
            </p:cNvSpPr>
            <p:nvPr/>
          </p:nvSpPr>
          <p:spPr bwMode="auto">
            <a:xfrm>
              <a:off x="4821238" y="1241460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5" name="Text Box 27"/>
            <p:cNvSpPr txBox="1">
              <a:spLocks noChangeArrowheads="1"/>
            </p:cNvSpPr>
            <p:nvPr/>
          </p:nvSpPr>
          <p:spPr bwMode="auto">
            <a:xfrm>
              <a:off x="1968500" y="2492410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6" name="Text Box 28"/>
            <p:cNvSpPr txBox="1">
              <a:spLocks noChangeArrowheads="1"/>
            </p:cNvSpPr>
            <p:nvPr/>
          </p:nvSpPr>
          <p:spPr bwMode="auto">
            <a:xfrm>
              <a:off x="3048000" y="2506698"/>
              <a:ext cx="304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200">
                  <a:latin typeface="Times New Roman" pitchFamily="18" charset="0"/>
                  <a:ea typeface="新細明體" pitchFamily="18" charset="-120"/>
                </a:rPr>
                <a:t>*</a:t>
              </a:r>
            </a:p>
          </p:txBody>
        </p:sp>
        <p:sp>
          <p:nvSpPr>
            <p:cNvPr id="7197" name="Text Box 29"/>
            <p:cNvSpPr txBox="1">
              <a:spLocks noChangeArrowheads="1"/>
            </p:cNvSpPr>
            <p:nvPr/>
          </p:nvSpPr>
          <p:spPr bwMode="auto">
            <a:xfrm>
              <a:off x="1905000" y="2478123"/>
              <a:ext cx="228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000">
                  <a:latin typeface="Times New Roman" pitchFamily="18" charset="0"/>
                  <a:ea typeface="新細明體" pitchFamily="18" charset="-120"/>
                </a:rPr>
                <a:t>#</a:t>
              </a:r>
            </a:p>
          </p:txBody>
        </p:sp>
        <p:sp>
          <p:nvSpPr>
            <p:cNvPr id="7198" name="Rectangle 30"/>
            <p:cNvSpPr>
              <a:spLocks noChangeArrowheads="1"/>
            </p:cNvSpPr>
            <p:nvPr/>
          </p:nvSpPr>
          <p:spPr bwMode="auto">
            <a:xfrm>
              <a:off x="5731200" y="6337317"/>
              <a:ext cx="269875" cy="11160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prstDash val="sysDot"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7199" name="Text Box 32"/>
            <p:cNvSpPr txBox="1">
              <a:spLocks noChangeArrowheads="1"/>
            </p:cNvSpPr>
            <p:nvPr/>
          </p:nvSpPr>
          <p:spPr bwMode="auto">
            <a:xfrm>
              <a:off x="3417888" y="2490823"/>
              <a:ext cx="228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000">
                  <a:latin typeface="Times New Roman" pitchFamily="18" charset="0"/>
                  <a:ea typeface="新細明體" pitchFamily="18" charset="-120"/>
                </a:rPr>
                <a:t>#</a:t>
              </a:r>
            </a:p>
          </p:txBody>
        </p:sp>
        <p:sp>
          <p:nvSpPr>
            <p:cNvPr id="7200" name="Text Box 33"/>
            <p:cNvSpPr txBox="1">
              <a:spLocks noChangeArrowheads="1"/>
            </p:cNvSpPr>
            <p:nvPr/>
          </p:nvSpPr>
          <p:spPr bwMode="auto">
            <a:xfrm>
              <a:off x="2306638" y="6164298"/>
              <a:ext cx="228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000">
                  <a:latin typeface="Times New Roman" pitchFamily="18" charset="0"/>
                  <a:ea typeface="新細明體" pitchFamily="18" charset="-120"/>
                </a:rPr>
                <a:t>#</a:t>
              </a:r>
            </a:p>
          </p:txBody>
        </p:sp>
        <p:sp>
          <p:nvSpPr>
            <p:cNvPr id="7201" name="Rectangle 34"/>
            <p:cNvSpPr>
              <a:spLocks noChangeArrowheads="1"/>
            </p:cNvSpPr>
            <p:nvPr/>
          </p:nvSpPr>
          <p:spPr bwMode="auto">
            <a:xfrm>
              <a:off x="3622675" y="1363698"/>
              <a:ext cx="215900" cy="11160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prstDash val="sysDot"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7202" name="Rectangle 40"/>
            <p:cNvSpPr>
              <a:spLocks noChangeArrowheads="1"/>
            </p:cNvSpPr>
            <p:nvPr/>
          </p:nvSpPr>
          <p:spPr bwMode="auto">
            <a:xfrm>
              <a:off x="4838400" y="6337317"/>
              <a:ext cx="215900" cy="11160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prstDash val="sysDot"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TW" altLang="en-US">
                <a:ea typeface="新細明體" pitchFamily="18" charset="-12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A4 Paper (210x297 mm)</PresentationFormat>
  <Paragraphs>8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1</cp:revision>
  <dcterms:created xsi:type="dcterms:W3CDTF">2011-04-07T14:16:33Z</dcterms:created>
  <dcterms:modified xsi:type="dcterms:W3CDTF">2011-04-07T14:17:23Z</dcterms:modified>
</cp:coreProperties>
</file>